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>
      <p:cViewPr varScale="1">
        <p:scale>
          <a:sx n="91" d="100"/>
          <a:sy n="91" d="100"/>
        </p:scale>
        <p:origin x="2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61722F-8ECA-4D1D-9FB2-31565D8442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0F75858-ED35-FB70-38D2-ECB56082CF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BD8E5FC-E7C7-1255-4799-88C9F743B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7118DBD-0835-A604-4A4A-1E8BF12CA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EDB35D4-E2F9-E042-63E0-FC1E5324B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8759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81F8A8A-A059-469A-6F52-0F812B17E1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95F3090-2215-E01D-98E4-53327FFB6F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AC649A-C594-3A2D-65C9-EECAAFFD5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88F4294-6A5B-DDFC-82F6-EB45D9D79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4740B9B-ACC6-F4BB-A65D-86DC59310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475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1062853-F288-824B-0F4F-CFFF180596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6C7EEC6-FCEB-D6A0-FF23-05971D1295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638BA5-B493-ED45-C759-1F07DABFE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30F6AC8-7D17-28BF-2FE6-62A2CF823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BF079D-DB2B-8791-F570-C6AB0C0BF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1989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1557CA-86E7-C8AD-668F-81B5B153E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FFF3054-2248-A52B-C3B6-EAE7942B23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D19B20-FB3E-4FB5-45EC-1B5016294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B04A8F-4631-92C0-785D-994BD8194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D0CD9D-85CB-A3FD-D6A6-9C5025AA9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1166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E79404-020E-B7FF-792A-8A2DEB56B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B38B53F-254E-D106-D4D4-D5F3A5FD87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19641F2-FD35-3483-FDB7-58C7EFD89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0E58F3F-60BD-509B-7006-02FCBBDED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9A55496-0416-3C0C-ECD0-758D8827D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394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981B9E-96BA-1A93-F5CF-A47509509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16F6589-68A6-B1B4-86C9-30CEF1262F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7AAE0C3-90BE-B451-FBAC-6083E17AC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C1EF3C9-9115-A806-29AF-A94E09F74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CC3B599-4629-3B15-26CC-67C2015EC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B1CEA5A-2B1E-72CA-1A44-A29720721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652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03A0633-E872-8385-9DA3-38D15AF77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7389F8E-E2F1-0310-0ECF-4270BBF61E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9F8A994-9C47-51FD-43B5-EF1FEA8D28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D29BD60-04F8-117F-6CA7-D5D8900A1A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761307B-B4EA-4C75-DADE-5C9A1D9868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7683E8B-8485-AEB2-4468-B471B083F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66562D4-1731-9983-E30C-4E4AD03FB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AB2516B-3011-6A01-F610-EFD29FB3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5535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EB230A-6071-5363-44C0-116FCBD9E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BA562A8-0788-F982-7E82-D8B91D618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635A7D8-F77E-BB24-5B64-3BE83DF98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09451CE-3BFB-B47D-9B8C-71058CFB7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021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CFFA549-9BE9-C22D-0D6B-FF9E5909E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EC2D33B-26F5-9E77-086C-8FB09F7B0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0CBF7E6-D558-57E0-F331-17677AC2D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6080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4A6AA2-58CA-4A61-974D-34F1454C7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CA7A6D0-6B26-4762-D63E-F2435A3FF1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ABBFFC5-9547-BF0E-FEAB-23F480E7A9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2701DD1-F190-BDCD-3AA2-BAF9FD265B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8418ECA-5EEC-FCFC-A8AB-DB8CD8E2C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E6EF7A7-99B5-0544-E951-C07D1E3C2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1437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3B0D1E-E186-2F6C-367E-BE7099D97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85BA8D6-7FE1-834C-9A8B-30B8705DC0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9A53603-FD28-00B6-5D7A-E94B937E9C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A4BE982-30D0-4DC3-93E0-2E52EA1E8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F6433D6-CA39-9061-26DB-05B39C8A1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FD5CD0E-5289-9DAC-7386-6FCABBE51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2147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38C1A60-C942-9596-6536-22D092F725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6F10233-1AC9-EEA8-DF8F-E1673C67C8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6FA28B4-BA5F-3B7A-5213-636E27EFD1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29EC7-D8A0-461F-8CA9-E5A886EECFB6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EBE0A9B-DB53-B072-D3EA-612082AD5F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E9BC66A-7504-08B8-B2D5-CF216D795F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3E8F0-9EF0-48AE-B4CF-B327148AC2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5944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8DE4B384-65F1-0E33-8E3E-8999A3583C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3601" y="163626"/>
            <a:ext cx="3965637" cy="572721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7587A52C-1B6D-E942-31A6-77DB6BFACEEB}"/>
              </a:ext>
            </a:extLst>
          </p:cNvPr>
          <p:cNvSpPr txBox="1"/>
          <p:nvPr/>
        </p:nvSpPr>
        <p:spPr>
          <a:xfrm>
            <a:off x="736841" y="5288340"/>
            <a:ext cx="535915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EQ5D-5L index value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 an overall measure of self-assesse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Qo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non-ICU COVID-19 patients mean EQ5D-5L index values were 0.78±0.33 after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months and 0.84±0.23 after 12 months. ICU patients had a worse overal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Qo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values of 0.71±0.27 and 0.74±0.2, respectively. The difference was significant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ed to non-ICU patients after 12-months (p=0.0013). Each data point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s an individual patient index value. Furthermore, the mean line ± SD are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played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816372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Breit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 Herrmann</dc:creator>
  <cp:lastModifiedBy>Johannes Herrmann</cp:lastModifiedBy>
  <cp:revision>2</cp:revision>
  <dcterms:created xsi:type="dcterms:W3CDTF">2023-04-16T19:55:34Z</dcterms:created>
  <dcterms:modified xsi:type="dcterms:W3CDTF">2023-04-16T19:57:51Z</dcterms:modified>
</cp:coreProperties>
</file>